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9981" autoAdjust="0"/>
    <p:restoredTop sz="94660"/>
  </p:normalViewPr>
  <p:slideViewPr>
    <p:cSldViewPr snapToGrid="0">
      <p:cViewPr varScale="1">
        <p:scale>
          <a:sx n="84" d="100"/>
          <a:sy n="84" d="100"/>
        </p:scale>
        <p:origin x="96" y="7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895944-4A67-4FFE-8BD3-3527CDED5CF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088054-18D2-46CC-979E-B35C8E6313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9745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97013" y="1200150"/>
            <a:ext cx="4321175" cy="32400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48507">
              <a:defRPr/>
            </a:pPr>
            <a:r>
              <a:rPr lang="en-US" b="1" dirty="0" smtClean="0"/>
              <a:t>Supplementary Figure 1. Characterization of new rabbit polyclonal</a:t>
            </a:r>
            <a:r>
              <a:rPr lang="en-US" b="1" baseline="0" dirty="0" smtClean="0"/>
              <a:t> anti-COX-1. </a:t>
            </a:r>
            <a:r>
              <a:rPr lang="en-US" b="1" dirty="0" smtClean="0"/>
              <a:t>A)</a:t>
            </a:r>
            <a:r>
              <a:rPr lang="en-US" dirty="0" smtClean="0"/>
              <a:t> Protein sequences</a:t>
            </a:r>
            <a:r>
              <a:rPr lang="en-US" baseline="0" dirty="0" smtClean="0"/>
              <a:t> of human COX-1 and COX-2 show that peptides used in anti-COX-1 generation (shaded in yellow) had no overlap with the corresponding COX-2 sequence. </a:t>
            </a:r>
            <a:r>
              <a:rPr lang="en-US" b="1" baseline="0" dirty="0" smtClean="0"/>
              <a:t>B) </a:t>
            </a:r>
            <a:r>
              <a:rPr lang="en-US" b="0" baseline="0" dirty="0" smtClean="0"/>
              <a:t>Western blot analysis using the newly generated Vanderbilt rabbit polyclonal anti-COX-1 (1:2000 overnight) show detection of COX-1 at the expected molecular weight (approx. 68kDa). COX-2 was detected by rabbit polyclonal anti-COX-2 (Cayman, (1:1000 overnight). Actin was used as loading control. Samples used were COX-1-expressing OVCAR-3 cell lysate, COX-2-expressing 4T1 cell lysate, recombinant ovine COX-1 and recombinant human COX-2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8D48CC-585D-4497-AE9D-5FE44C36E62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699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913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279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437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758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129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72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575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9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570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631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331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F89A6-1539-4E7D-A332-E2255011A7EC}" type="datetimeFigureOut">
              <a:rPr lang="en-US" smtClean="0"/>
              <a:t>9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81ABE0-B5E0-4AE8-9240-3FF18A2B7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492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838956" y="701938"/>
            <a:ext cx="13773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</a:t>
            </a:r>
            <a:endParaRPr lang="en-US" sz="1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855506" y="1323492"/>
            <a:ext cx="451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t="-1" r="10747" b="2326"/>
          <a:stretch/>
        </p:blipFill>
        <p:spPr>
          <a:xfrm>
            <a:off x="1238860" y="1370615"/>
            <a:ext cx="3535677" cy="3840480"/>
          </a:xfrm>
          <a:prstGeom prst="rect">
            <a:avLst/>
          </a:prstGeom>
        </p:spPr>
      </p:pic>
      <p:sp>
        <p:nvSpPr>
          <p:cNvPr id="54" name="TextBox 53"/>
          <p:cNvSpPr txBox="1"/>
          <p:nvPr/>
        </p:nvSpPr>
        <p:spPr>
          <a:xfrm>
            <a:off x="829431" y="1323492"/>
            <a:ext cx="451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32" r="43049"/>
          <a:stretch/>
        </p:blipFill>
        <p:spPr>
          <a:xfrm>
            <a:off x="5589486" y="2212280"/>
            <a:ext cx="9144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2" name="Straight Connector 21"/>
          <p:cNvCxnSpPr/>
          <p:nvPr/>
        </p:nvCxnSpPr>
        <p:spPr>
          <a:xfrm flipV="1">
            <a:off x="5491837" y="3471912"/>
            <a:ext cx="165396" cy="3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V="1">
            <a:off x="5491837" y="3176219"/>
            <a:ext cx="165396" cy="3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V="1">
            <a:off x="5491837" y="2775340"/>
            <a:ext cx="165396" cy="3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5491837" y="2582128"/>
            <a:ext cx="165396" cy="3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V="1">
            <a:off x="5491837" y="2356654"/>
            <a:ext cx="165396" cy="3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5055000" y="336418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055000" y="3080267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055000" y="2664751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997292" y="2472807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5435850" y="1824633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OVCAR-3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5763527" y="196649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4T1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5840349" y="1867113"/>
            <a:ext cx="5613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oCOX-1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6035618" y="1867113"/>
            <a:ext cx="5613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hCOX-2</a:t>
            </a:r>
          </a:p>
        </p:txBody>
      </p:sp>
      <p:sp>
        <p:nvSpPr>
          <p:cNvPr id="35" name="TextBox 34"/>
          <p:cNvSpPr txBox="1"/>
          <p:nvPr/>
        </p:nvSpPr>
        <p:spPr>
          <a:xfrm rot="16200000">
            <a:off x="6389451" y="1824633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OVCAR-3</a:t>
            </a:r>
          </a:p>
        </p:txBody>
      </p:sp>
      <p:sp>
        <p:nvSpPr>
          <p:cNvPr id="36" name="TextBox 35"/>
          <p:cNvSpPr txBox="1"/>
          <p:nvPr/>
        </p:nvSpPr>
        <p:spPr>
          <a:xfrm rot="16200000">
            <a:off x="6717128" y="196649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4T1</a:t>
            </a:r>
          </a:p>
        </p:txBody>
      </p:sp>
      <p:sp>
        <p:nvSpPr>
          <p:cNvPr id="37" name="TextBox 36"/>
          <p:cNvSpPr txBox="1"/>
          <p:nvPr/>
        </p:nvSpPr>
        <p:spPr>
          <a:xfrm rot="16200000">
            <a:off x="6808018" y="1867113"/>
            <a:ext cx="5613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oCOX-1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7003287" y="1867113"/>
            <a:ext cx="5613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hCOX-2</a:t>
            </a: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39" r="931"/>
          <a:stretch/>
        </p:blipFill>
        <p:spPr>
          <a:xfrm>
            <a:off x="6569531" y="2212280"/>
            <a:ext cx="877824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6" name="TextBox 45"/>
          <p:cNvSpPr txBox="1"/>
          <p:nvPr/>
        </p:nvSpPr>
        <p:spPr>
          <a:xfrm>
            <a:off x="4997292" y="2252267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510394" y="1452365"/>
            <a:ext cx="1098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u="sng" dirty="0">
                <a:latin typeface="Arial" panose="020B0604020202020204" pitchFamily="34" charset="0"/>
                <a:cs typeface="Arial" panose="020B0604020202020204" pitchFamily="34" charset="0"/>
              </a:rPr>
              <a:t>COX-1 (Vanderbilt)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6770173" y="1452365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u="sng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7713491" y="1448964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u="sng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52" name="Picture 51"/>
          <p:cNvPicPr preferRelativeResize="0">
            <a:picLocks/>
          </p:cNvPicPr>
          <p:nvPr/>
        </p:nvPicPr>
        <p:blipFill rotWithShape="1">
          <a:blip r:embed="rId6">
            <a:lum bright="-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4" r="10121" b="25258"/>
          <a:stretch/>
        </p:blipFill>
        <p:spPr>
          <a:xfrm>
            <a:off x="7507961" y="2212280"/>
            <a:ext cx="877824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3" name="TextBox 52"/>
          <p:cNvSpPr txBox="1"/>
          <p:nvPr/>
        </p:nvSpPr>
        <p:spPr>
          <a:xfrm rot="16200000">
            <a:off x="7331225" y="1824633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OVCAR-3</a:t>
            </a:r>
          </a:p>
        </p:txBody>
      </p:sp>
      <p:sp>
        <p:nvSpPr>
          <p:cNvPr id="58" name="TextBox 57"/>
          <p:cNvSpPr txBox="1"/>
          <p:nvPr/>
        </p:nvSpPr>
        <p:spPr>
          <a:xfrm rot="16200000">
            <a:off x="7658902" y="196649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4T1</a:t>
            </a:r>
          </a:p>
        </p:txBody>
      </p:sp>
      <p:sp>
        <p:nvSpPr>
          <p:cNvPr id="59" name="TextBox 58"/>
          <p:cNvSpPr txBox="1"/>
          <p:nvPr/>
        </p:nvSpPr>
        <p:spPr>
          <a:xfrm rot="16200000">
            <a:off x="7749792" y="1867113"/>
            <a:ext cx="5613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oCOX-1</a:t>
            </a:r>
          </a:p>
        </p:txBody>
      </p:sp>
      <p:sp>
        <p:nvSpPr>
          <p:cNvPr id="60" name="TextBox 59"/>
          <p:cNvSpPr txBox="1"/>
          <p:nvPr/>
        </p:nvSpPr>
        <p:spPr>
          <a:xfrm rot="16200000">
            <a:off x="7945061" y="1867113"/>
            <a:ext cx="5613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itchFamily="34" charset="0"/>
                <a:cs typeface="Arial" pitchFamily="34" charset="0"/>
              </a:rPr>
              <a:t>hCOX-2</a:t>
            </a:r>
          </a:p>
        </p:txBody>
      </p:sp>
    </p:spTree>
    <p:extLst>
      <p:ext uri="{BB962C8B-B14F-4D97-AF65-F5344CB8AC3E}">
        <p14:creationId xmlns:p14="http://schemas.microsoft.com/office/powerpoint/2010/main" val="1557490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45</Words>
  <Application>Microsoft Office PowerPoint</Application>
  <PresentationFormat>On-screen Show (4:3)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son, Andrew J</dc:creator>
  <cp:lastModifiedBy>Younger, Marshal S</cp:lastModifiedBy>
  <cp:revision>1</cp:revision>
  <dcterms:created xsi:type="dcterms:W3CDTF">2017-04-19T20:41:05Z</dcterms:created>
  <dcterms:modified xsi:type="dcterms:W3CDTF">2017-09-21T18:03:47Z</dcterms:modified>
</cp:coreProperties>
</file>